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9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BEC68"/>
    <a:srgbClr val="7FFF43"/>
    <a:srgbClr val="AAFFAA"/>
    <a:srgbClr val="95FF95"/>
    <a:srgbClr val="FFD6D6"/>
    <a:srgbClr val="F4FFF5"/>
    <a:srgbClr val="FFFFFF"/>
    <a:srgbClr val="D5FFD5"/>
    <a:srgbClr val="B5FFB6"/>
    <a:srgbClr val="BFFF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96461"/>
  </p:normalViewPr>
  <p:slideViewPr>
    <p:cSldViewPr snapToGrid="0">
      <p:cViewPr varScale="1">
        <p:scale>
          <a:sx n="95" d="100"/>
          <a:sy n="95" d="100"/>
        </p:scale>
        <p:origin x="2336" y="20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76" d="100"/>
        <a:sy n="7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0DA2E1-DD46-444F-9C07-76BE7069E025}" type="datetimeFigureOut">
              <a:rPr lang="en-US" smtClean="0"/>
              <a:t>9/1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93F3EF-40F3-4B4E-8DD1-7B87CED4C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7291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571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679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566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284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581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291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327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051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316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073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699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0E2F19-C424-D84A-8502-E4CFF9BCB90B}" type="datetimeFigureOut">
              <a:rPr lang="en-US" smtClean="0"/>
              <a:t>9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600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0997213-8CC5-A603-067A-D431E5F943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816392D-EC0C-D224-AD78-26936C17925C}"/>
              </a:ext>
            </a:extLst>
          </p:cNvPr>
          <p:cNvSpPr txBox="1"/>
          <p:nvPr/>
        </p:nvSpPr>
        <p:spPr>
          <a:xfrm>
            <a:off x="101891" y="7007006"/>
            <a:ext cx="6638544" cy="9296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Figure 5: Non-significant Male Bone WGCNA.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odule trait relationship heatmaps from WGCNA analysis from male </a:t>
            </a:r>
            <a:r>
              <a:rPr lang="en-US" sz="1200" i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POE2/3/4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bone proteomics revealed no significant enrichment for regulation related to APOE allele status.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One cluster (Blue) trended toward a significant relationship to APOE alleles at p = 0.06. * = significance at p &lt; 0.05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C22BA7F9-9EAB-C9CD-6CBA-B01F54509B89}"/>
              </a:ext>
            </a:extLst>
          </p:cNvPr>
          <p:cNvGrpSpPr/>
          <p:nvPr/>
        </p:nvGrpSpPr>
        <p:grpSpPr>
          <a:xfrm>
            <a:off x="4992104" y="1925053"/>
            <a:ext cx="660935" cy="4091192"/>
            <a:chOff x="5073814" y="2542197"/>
            <a:chExt cx="178317" cy="1088872"/>
          </a:xfrm>
        </p:grpSpPr>
        <p:pic>
          <p:nvPicPr>
            <p:cNvPr id="27" name="Google Shape;151;p28">
              <a:extLst>
                <a:ext uri="{FF2B5EF4-FFF2-40B4-BE49-F238E27FC236}">
                  <a16:creationId xmlns:a16="http://schemas.microsoft.com/office/drawing/2014/main" id="{44C3358B-7514-AEC1-6BE6-8CBB21C733E3}"/>
                </a:ext>
              </a:extLst>
            </p:cNvPr>
            <p:cNvPicPr preferRelativeResize="0"/>
            <p:nvPr/>
          </p:nvPicPr>
          <p:blipFill rotWithShape="1">
            <a:blip r:embed="rId2">
              <a:alphaModFix/>
            </a:blip>
            <a:srcRect l="91442" r="6407"/>
            <a:stretch/>
          </p:blipFill>
          <p:spPr>
            <a:xfrm>
              <a:off x="5073814" y="2542197"/>
              <a:ext cx="49593" cy="108887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B854B30-DEAB-732A-C1C2-A1E07C5BB09F}"/>
                </a:ext>
              </a:extLst>
            </p:cNvPr>
            <p:cNvSpPr txBox="1"/>
            <p:nvPr/>
          </p:nvSpPr>
          <p:spPr>
            <a:xfrm>
              <a:off x="5114913" y="2600172"/>
              <a:ext cx="80529" cy="901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F0EC791-1B59-3D7E-D909-E9D877229AD7}"/>
                </a:ext>
              </a:extLst>
            </p:cNvPr>
            <p:cNvSpPr txBox="1"/>
            <p:nvPr/>
          </p:nvSpPr>
          <p:spPr>
            <a:xfrm>
              <a:off x="5110822" y="3427959"/>
              <a:ext cx="99126" cy="901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518C328-1FA8-3D70-D285-C1A764552863}"/>
                </a:ext>
              </a:extLst>
            </p:cNvPr>
            <p:cNvSpPr txBox="1"/>
            <p:nvPr/>
          </p:nvSpPr>
          <p:spPr>
            <a:xfrm>
              <a:off x="5106729" y="3009363"/>
              <a:ext cx="80529" cy="901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20CB9E4-82E6-5FD1-7F17-6EBFAD270701}"/>
                </a:ext>
              </a:extLst>
            </p:cNvPr>
            <p:cNvSpPr txBox="1"/>
            <p:nvPr/>
          </p:nvSpPr>
          <p:spPr>
            <a:xfrm>
              <a:off x="5104682" y="2801075"/>
              <a:ext cx="126805" cy="901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20651F2-244D-1554-27D4-BAFC86A2F3F3}"/>
                </a:ext>
              </a:extLst>
            </p:cNvPr>
            <p:cNvSpPr txBox="1"/>
            <p:nvPr/>
          </p:nvSpPr>
          <p:spPr>
            <a:xfrm>
              <a:off x="5106729" y="3217558"/>
              <a:ext cx="145402" cy="901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0.5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E84C93FB-871A-5A26-B29F-C7C4CC2BF58C}"/>
              </a:ext>
            </a:extLst>
          </p:cNvPr>
          <p:cNvGrpSpPr/>
          <p:nvPr/>
        </p:nvGrpSpPr>
        <p:grpSpPr>
          <a:xfrm>
            <a:off x="1718546" y="1786861"/>
            <a:ext cx="2999865" cy="4252337"/>
            <a:chOff x="1718546" y="1786861"/>
            <a:chExt cx="2999865" cy="4252337"/>
          </a:xfrm>
        </p:grpSpPr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5BA5B77B-52C9-749F-01F9-5B63A9D22BF4}"/>
                </a:ext>
              </a:extLst>
            </p:cNvPr>
            <p:cNvSpPr/>
            <p:nvPr/>
          </p:nvSpPr>
          <p:spPr>
            <a:xfrm>
              <a:off x="1718546" y="2207057"/>
              <a:ext cx="1401559" cy="429967"/>
            </a:xfrm>
            <a:prstGeom prst="rect">
              <a:avLst/>
            </a:prstGeom>
            <a:solidFill>
              <a:srgbClr val="02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een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617B7229-C4BC-0C70-D98D-5066C1C11645}"/>
                </a:ext>
              </a:extLst>
            </p:cNvPr>
            <p:cNvSpPr/>
            <p:nvPr/>
          </p:nvSpPr>
          <p:spPr>
            <a:xfrm>
              <a:off x="1718546" y="1786861"/>
              <a:ext cx="1401559" cy="429967"/>
            </a:xfrm>
            <a:prstGeom prst="rect">
              <a:avLst/>
            </a:prstGeom>
            <a:solidFill>
              <a:srgbClr val="A5292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rown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B13F9C74-D4C6-F8CB-4444-87DEA8453C35}"/>
                </a:ext>
              </a:extLst>
            </p:cNvPr>
            <p:cNvSpPr/>
            <p:nvPr/>
          </p:nvSpPr>
          <p:spPr>
            <a:xfrm>
              <a:off x="1718546" y="2637024"/>
              <a:ext cx="1401559" cy="429967"/>
            </a:xfrm>
            <a:prstGeom prst="rect">
              <a:avLst/>
            </a:prstGeom>
            <a:solidFill>
              <a:srgbClr val="FF00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genta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09E109C4-09DF-9563-F23A-BA362A3997B8}"/>
                </a:ext>
              </a:extLst>
            </p:cNvPr>
            <p:cNvSpPr/>
            <p:nvPr/>
          </p:nvSpPr>
          <p:spPr>
            <a:xfrm>
              <a:off x="1718546" y="3066989"/>
              <a:ext cx="1401559" cy="429967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lue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EB2F6E49-895C-C39F-D6CC-929B0FEAC9A3}"/>
                </a:ext>
              </a:extLst>
            </p:cNvPr>
            <p:cNvSpPr/>
            <p:nvPr/>
          </p:nvSpPr>
          <p:spPr>
            <a:xfrm>
              <a:off x="1718546" y="3487181"/>
              <a:ext cx="1401559" cy="429967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ellow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11DDDE70-9935-CA28-CB63-E9AF3E36C3B7}"/>
                </a:ext>
              </a:extLst>
            </p:cNvPr>
            <p:cNvSpPr/>
            <p:nvPr/>
          </p:nvSpPr>
          <p:spPr>
            <a:xfrm>
              <a:off x="3127689" y="1786861"/>
              <a:ext cx="1590722" cy="429967"/>
            </a:xfrm>
            <a:prstGeom prst="rect">
              <a:avLst/>
            </a:prstGeom>
            <a:solidFill>
              <a:srgbClr val="AAFFA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36 (0.2)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16D7CEC5-A1E7-CC37-EDB0-0E8A3378DFF8}"/>
                </a:ext>
              </a:extLst>
            </p:cNvPr>
            <p:cNvSpPr/>
            <p:nvPr/>
          </p:nvSpPr>
          <p:spPr>
            <a:xfrm>
              <a:off x="3127689" y="2207057"/>
              <a:ext cx="1590722" cy="429967"/>
            </a:xfrm>
            <a:prstGeom prst="rect">
              <a:avLst/>
            </a:prstGeom>
            <a:solidFill>
              <a:srgbClr val="FFDFE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7 (0.5)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701FAEE2-94A6-99E2-B5AE-C3CC9662E068}"/>
                </a:ext>
              </a:extLst>
            </p:cNvPr>
            <p:cNvSpPr/>
            <p:nvPr/>
          </p:nvSpPr>
          <p:spPr>
            <a:xfrm>
              <a:off x="3127689" y="2637024"/>
              <a:ext cx="1590722" cy="429967"/>
            </a:xfrm>
            <a:prstGeom prst="rect">
              <a:avLst/>
            </a:prstGeom>
            <a:solidFill>
              <a:srgbClr val="DFFFD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14 (0.6)</a:t>
              </a: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883E9258-1BE9-4C99-6476-3B87A1F1B636}"/>
                </a:ext>
              </a:extLst>
            </p:cNvPr>
            <p:cNvSpPr/>
            <p:nvPr/>
          </p:nvSpPr>
          <p:spPr>
            <a:xfrm>
              <a:off x="3127689" y="3066989"/>
              <a:ext cx="1590722" cy="429967"/>
            </a:xfrm>
            <a:prstGeom prst="rect">
              <a:avLst/>
            </a:prstGeom>
            <a:solidFill>
              <a:srgbClr val="80FF8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5 (0.06)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4088C0CE-DC9C-00BB-C866-525E0F1F96EF}"/>
                </a:ext>
              </a:extLst>
            </p:cNvPr>
            <p:cNvSpPr/>
            <p:nvPr/>
          </p:nvSpPr>
          <p:spPr>
            <a:xfrm>
              <a:off x="3127689" y="3487181"/>
              <a:ext cx="1590722" cy="429967"/>
            </a:xfrm>
            <a:prstGeom prst="rect">
              <a:avLst/>
            </a:prstGeom>
            <a:solidFill>
              <a:srgbClr val="AAFFA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34 (0.2)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3043C24F-CEFB-3E27-733D-AAAC44DA73CD}"/>
                </a:ext>
              </a:extLst>
            </p:cNvPr>
            <p:cNvSpPr/>
            <p:nvPr/>
          </p:nvSpPr>
          <p:spPr>
            <a:xfrm>
              <a:off x="1718546" y="3916191"/>
              <a:ext cx="1401559" cy="429967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lack</a:t>
              </a: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77EF94A0-44D2-F79E-E389-9348CE197AB2}"/>
                </a:ext>
              </a:extLst>
            </p:cNvPr>
            <p:cNvSpPr/>
            <p:nvPr/>
          </p:nvSpPr>
          <p:spPr>
            <a:xfrm>
              <a:off x="1718546" y="4338576"/>
              <a:ext cx="1401559" cy="429967"/>
            </a:xfrm>
            <a:prstGeom prst="rect">
              <a:avLst/>
            </a:prstGeom>
            <a:solidFill>
              <a:srgbClr val="FFC0CB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ink</a:t>
              </a: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8C541285-2E9B-11A6-F4F1-09243FAF6D0C}"/>
                </a:ext>
              </a:extLst>
            </p:cNvPr>
            <p:cNvSpPr/>
            <p:nvPr/>
          </p:nvSpPr>
          <p:spPr>
            <a:xfrm>
              <a:off x="1718546" y="4757203"/>
              <a:ext cx="1401559" cy="429967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d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DE9A3D79-6A1A-5950-2E34-2A33A53E48FB}"/>
                </a:ext>
              </a:extLst>
            </p:cNvPr>
            <p:cNvSpPr/>
            <p:nvPr/>
          </p:nvSpPr>
          <p:spPr>
            <a:xfrm>
              <a:off x="3127689" y="3916191"/>
              <a:ext cx="1590722" cy="429967"/>
            </a:xfrm>
            <a:prstGeom prst="rect">
              <a:avLst/>
            </a:prstGeom>
            <a:solidFill>
              <a:srgbClr val="CBFFC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24 (0.4)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AAFD2AAD-DC4A-9492-ED10-3771F935B55B}"/>
                </a:ext>
              </a:extLst>
            </p:cNvPr>
            <p:cNvSpPr/>
            <p:nvPr/>
          </p:nvSpPr>
          <p:spPr>
            <a:xfrm>
              <a:off x="3127689" y="4338576"/>
              <a:ext cx="1590722" cy="429967"/>
            </a:xfrm>
            <a:prstGeom prst="rect">
              <a:avLst/>
            </a:prstGeom>
            <a:solidFill>
              <a:srgbClr val="F4FFF5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085 (0.8)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7FEAE1A3-100E-CA48-9CB5-7BF4276A6471}"/>
                </a:ext>
              </a:extLst>
            </p:cNvPr>
            <p:cNvSpPr/>
            <p:nvPr/>
          </p:nvSpPr>
          <p:spPr>
            <a:xfrm>
              <a:off x="3127689" y="4757203"/>
              <a:ext cx="1590722" cy="429967"/>
            </a:xfrm>
            <a:prstGeom prst="rect">
              <a:avLst/>
            </a:prstGeom>
            <a:solidFill>
              <a:srgbClr val="FFAAA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34 (0.2)</a:t>
              </a: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5DC968D6-5E65-CBD6-BD76-104A6DA03BB0}"/>
                </a:ext>
              </a:extLst>
            </p:cNvPr>
            <p:cNvSpPr/>
            <p:nvPr/>
          </p:nvSpPr>
          <p:spPr>
            <a:xfrm>
              <a:off x="1718546" y="5179430"/>
              <a:ext cx="1401559" cy="429967"/>
            </a:xfrm>
            <a:prstGeom prst="rect">
              <a:avLst/>
            </a:prstGeom>
            <a:solidFill>
              <a:srgbClr val="3FE1D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rquoise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1C35772C-5A43-CEC4-9798-2CBD003E2F6A}"/>
                </a:ext>
              </a:extLst>
            </p:cNvPr>
            <p:cNvSpPr/>
            <p:nvPr/>
          </p:nvSpPr>
          <p:spPr>
            <a:xfrm>
              <a:off x="3127689" y="5179430"/>
              <a:ext cx="1590722" cy="429967"/>
            </a:xfrm>
            <a:prstGeom prst="rect">
              <a:avLst/>
            </a:prstGeom>
            <a:solidFill>
              <a:srgbClr val="FF9F9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4 (0.1)</a:t>
              </a: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EE5F8E0A-3333-928F-E5DD-E0990E65474A}"/>
                </a:ext>
              </a:extLst>
            </p:cNvPr>
            <p:cNvSpPr/>
            <p:nvPr/>
          </p:nvSpPr>
          <p:spPr>
            <a:xfrm>
              <a:off x="1718546" y="5609231"/>
              <a:ext cx="1401559" cy="429967"/>
            </a:xfrm>
            <a:prstGeom prst="rect">
              <a:avLst/>
            </a:prstGeom>
            <a:solidFill>
              <a:srgbClr val="BEBEBE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ey</a:t>
              </a: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4287250B-F5BA-7FAA-2A58-EB7EA2115453}"/>
                </a:ext>
              </a:extLst>
            </p:cNvPr>
            <p:cNvSpPr/>
            <p:nvPr/>
          </p:nvSpPr>
          <p:spPr>
            <a:xfrm>
              <a:off x="3127689" y="5609231"/>
              <a:ext cx="1590722" cy="429967"/>
            </a:xfrm>
            <a:prstGeom prst="rect">
              <a:avLst/>
            </a:prstGeom>
            <a:solidFill>
              <a:srgbClr val="AAFFA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35 (0.2)</a:t>
              </a: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149FFC89-C263-8467-3BE2-BC19B8251482}"/>
              </a:ext>
            </a:extLst>
          </p:cNvPr>
          <p:cNvSpPr txBox="1"/>
          <p:nvPr/>
        </p:nvSpPr>
        <p:spPr>
          <a:xfrm>
            <a:off x="1904143" y="1210925"/>
            <a:ext cx="2797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Module Trait Relationships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8282778-D0C4-EEC6-D614-1EF96ADD896A}"/>
              </a:ext>
            </a:extLst>
          </p:cNvPr>
          <p:cNvSpPr txBox="1"/>
          <p:nvPr/>
        </p:nvSpPr>
        <p:spPr>
          <a:xfrm>
            <a:off x="3200672" y="1543706"/>
            <a:ext cx="14478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earson 𝑟</a:t>
            </a:r>
            <a:r>
              <a:rPr lang="en-US" sz="1200" dirty="0"/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p-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va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7D22116-D554-5F66-3624-10184A931E64}"/>
              </a:ext>
            </a:extLst>
          </p:cNvPr>
          <p:cNvSpPr txBox="1"/>
          <p:nvPr/>
        </p:nvSpPr>
        <p:spPr>
          <a:xfrm>
            <a:off x="1669979" y="1485216"/>
            <a:ext cx="309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♂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71DA2A2-12FC-4027-8DFD-38E129688D18}"/>
              </a:ext>
            </a:extLst>
          </p:cNvPr>
          <p:cNvSpPr txBox="1"/>
          <p:nvPr/>
        </p:nvSpPr>
        <p:spPr>
          <a:xfrm>
            <a:off x="4954494" y="1907099"/>
            <a:ext cx="3824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𝑟</a:t>
            </a:r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00EEEEE-9229-D8B0-403C-4CC44B4D5B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61695">
            <a:off x="2188031" y="1462747"/>
            <a:ext cx="635179" cy="3491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6419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855</TotalTime>
  <Words>132</Words>
  <Application>Microsoft Macintosh PowerPoint</Application>
  <PresentationFormat>Letter Paper (8.5x11 in)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arlie Schurman</dc:creator>
  <cp:lastModifiedBy>Charlie Schurman</cp:lastModifiedBy>
  <cp:revision>167</cp:revision>
  <dcterms:created xsi:type="dcterms:W3CDTF">2025-03-26T18:06:09Z</dcterms:created>
  <dcterms:modified xsi:type="dcterms:W3CDTF">2025-09-19T17:05:59Z</dcterms:modified>
</cp:coreProperties>
</file>